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32" autoAdjust="0"/>
    <p:restoredTop sz="93738" autoAdjust="0"/>
  </p:normalViewPr>
  <p:slideViewPr>
    <p:cSldViewPr snapToGrid="0">
      <p:cViewPr varScale="1">
        <p:scale>
          <a:sx n="45" d="100"/>
          <a:sy n="45" d="100"/>
        </p:scale>
        <p:origin x="13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4431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4164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529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32239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821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2183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2106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8702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5300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7235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9269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4411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D3D3946-A4F3-4CD2-AE3D-FDBC1CA6DC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2119" y="6496961"/>
            <a:ext cx="4048272" cy="541329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79FA457-FFC6-47A6-AAB6-99CECD831B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2641" y="6496960"/>
            <a:ext cx="4048272" cy="541329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69A6E40-819D-46C4-9AA5-FDBFE07327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140129" y="1622314"/>
            <a:ext cx="5413296" cy="404827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A5F5F7B-99C7-4090-A70B-78151FD7D4F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2119" y="939803"/>
            <a:ext cx="4048272" cy="541329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4928D00-CB0A-455F-98D9-F0603A4DF819}"/>
              </a:ext>
            </a:extLst>
          </p:cNvPr>
          <p:cNvSpPr txBox="1"/>
          <p:nvPr/>
        </p:nvSpPr>
        <p:spPr>
          <a:xfrm>
            <a:off x="943428" y="12306300"/>
            <a:ext cx="10277021" cy="1513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4. Cell tracing experiment demonstrates GFP-positive M-CSF-cultured myeloid cells in hair follicle-like structures in wounded skin of mice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received dermal injection of one million GFP-positive, M-CSF-cultured myeloid cells were created excisional dermal wounds by punch biopsy. Mice were euthanized after 4 weeks and skin was collected and immunofluorescent stained for detection of GFP (green). DAPI (blue) was used as a nuclear counterstain. Scale bars in all images were 50 µm.. 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2B939B0-EE21-4019-8330-734F3F0E45C2}"/>
              </a:ext>
            </a:extLst>
          </p:cNvPr>
          <p:cNvCxnSpPr>
            <a:cxnSpLocks/>
          </p:cNvCxnSpPr>
          <p:nvPr/>
        </p:nvCxnSpPr>
        <p:spPr>
          <a:xfrm>
            <a:off x="4886325" y="6200775"/>
            <a:ext cx="75247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FA00CFE-6CC5-446C-BA87-F3B1FB56FCA7}"/>
              </a:ext>
            </a:extLst>
          </p:cNvPr>
          <p:cNvCxnSpPr>
            <a:cxnSpLocks/>
          </p:cNvCxnSpPr>
          <p:nvPr/>
        </p:nvCxnSpPr>
        <p:spPr>
          <a:xfrm>
            <a:off x="9115425" y="6200775"/>
            <a:ext cx="75247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8811F47-4A28-430F-B407-8150A3A1E5BC}"/>
              </a:ext>
            </a:extLst>
          </p:cNvPr>
          <p:cNvCxnSpPr>
            <a:cxnSpLocks/>
          </p:cNvCxnSpPr>
          <p:nvPr/>
        </p:nvCxnSpPr>
        <p:spPr>
          <a:xfrm>
            <a:off x="5326743" y="11753850"/>
            <a:ext cx="3977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C8A2A38-9290-405C-BE14-2ABDC33A8367}"/>
              </a:ext>
            </a:extLst>
          </p:cNvPr>
          <p:cNvCxnSpPr>
            <a:cxnSpLocks/>
          </p:cNvCxnSpPr>
          <p:nvPr/>
        </p:nvCxnSpPr>
        <p:spPr>
          <a:xfrm>
            <a:off x="9463314" y="11772900"/>
            <a:ext cx="40458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80940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0</TotalTime>
  <Words>82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nyuan</dc:creator>
  <cp:lastModifiedBy>chn off31</cp:lastModifiedBy>
  <cp:revision>65</cp:revision>
  <dcterms:created xsi:type="dcterms:W3CDTF">2018-08-16T19:41:08Z</dcterms:created>
  <dcterms:modified xsi:type="dcterms:W3CDTF">2022-06-15T08:49:51Z</dcterms:modified>
</cp:coreProperties>
</file>